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085388" cy="14401800"/>
  <p:notesSz cx="6858000" cy="9144000"/>
  <p:defaultTextStyle>
    <a:defPPr>
      <a:defRPr lang="en-US"/>
    </a:defPPr>
    <a:lvl1pPr marL="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69960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39921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09882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79843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49803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19764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489725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59686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4" d="100"/>
          <a:sy n="54" d="100"/>
        </p:scale>
        <p:origin x="-2360" y="-104"/>
      </p:cViewPr>
      <p:guideLst>
        <p:guide orient="horz" pos="4536"/>
        <p:guide pos="317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404" y="4473893"/>
            <a:ext cx="8572580" cy="308705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12808" y="8161020"/>
            <a:ext cx="7059772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96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99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988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9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98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976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97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9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797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205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11906" y="576741"/>
            <a:ext cx="2269212" cy="12288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4269" y="576741"/>
            <a:ext cx="6639547" cy="12288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8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970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6676" y="9254491"/>
            <a:ext cx="8572580" cy="2860358"/>
          </a:xfrm>
        </p:spPr>
        <p:txBody>
          <a:bodyPr anchor="t"/>
          <a:lstStyle>
            <a:lvl1pPr algn="l">
              <a:defRPr sz="61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6676" y="6104098"/>
            <a:ext cx="8572580" cy="3150393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699607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39921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9882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9843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9803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9764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9725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968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214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426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673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273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69" y="3223737"/>
            <a:ext cx="4456131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4269" y="4567237"/>
            <a:ext cx="4456131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23237" y="3223737"/>
            <a:ext cx="4457882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23237" y="4567237"/>
            <a:ext cx="4457882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031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070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313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270" y="573405"/>
            <a:ext cx="3318023" cy="2440305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43107" y="573406"/>
            <a:ext cx="5638012" cy="12291537"/>
          </a:xfrm>
        </p:spPr>
        <p:txBody>
          <a:bodyPr/>
          <a:lstStyle>
            <a:lvl1pPr>
              <a:defRPr sz="4900"/>
            </a:lvl1pPr>
            <a:lvl2pPr>
              <a:defRPr sz="4300"/>
            </a:lvl2pPr>
            <a:lvl3pPr>
              <a:defRPr sz="37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4270" y="3013711"/>
            <a:ext cx="3318023" cy="9851232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372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6807" y="10081260"/>
            <a:ext cx="6051233" cy="119015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6807" y="1286828"/>
            <a:ext cx="6051233" cy="8641080"/>
          </a:xfrm>
        </p:spPr>
        <p:txBody>
          <a:bodyPr/>
          <a:lstStyle>
            <a:lvl1pPr marL="0" indent="0">
              <a:buNone/>
              <a:defRPr sz="4900"/>
            </a:lvl1pPr>
            <a:lvl2pPr marL="699607" indent="0">
              <a:buNone/>
              <a:defRPr sz="4300"/>
            </a:lvl2pPr>
            <a:lvl3pPr marL="1399215" indent="0">
              <a:buNone/>
              <a:defRPr sz="3700"/>
            </a:lvl3pPr>
            <a:lvl4pPr marL="2098822" indent="0">
              <a:buNone/>
              <a:defRPr sz="3100"/>
            </a:lvl4pPr>
            <a:lvl5pPr marL="2798430" indent="0">
              <a:buNone/>
              <a:defRPr sz="3100"/>
            </a:lvl5pPr>
            <a:lvl6pPr marL="3498037" indent="0">
              <a:buNone/>
              <a:defRPr sz="3100"/>
            </a:lvl6pPr>
            <a:lvl7pPr marL="4197645" indent="0">
              <a:buNone/>
              <a:defRPr sz="3100"/>
            </a:lvl7pPr>
            <a:lvl8pPr marL="4897252" indent="0">
              <a:buNone/>
              <a:defRPr sz="3100"/>
            </a:lvl8pPr>
            <a:lvl9pPr marL="5596860" indent="0">
              <a:buNone/>
              <a:defRPr sz="3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6807" y="11271410"/>
            <a:ext cx="6051233" cy="1690210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027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4270" y="576740"/>
            <a:ext cx="9076849" cy="2400300"/>
          </a:xfrm>
          <a:prstGeom prst="rect">
            <a:avLst/>
          </a:prstGeom>
        </p:spPr>
        <p:txBody>
          <a:bodyPr vert="horz" lIns="139921" tIns="69961" rIns="139921" bIns="69961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70" y="3360421"/>
            <a:ext cx="9076849" cy="9504522"/>
          </a:xfrm>
          <a:prstGeom prst="rect">
            <a:avLst/>
          </a:prstGeom>
        </p:spPr>
        <p:txBody>
          <a:bodyPr vert="horz" lIns="139921" tIns="69961" rIns="139921" bIns="69961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4270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7B768-754C-7543-9A09-B4E6D6292173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5841" y="13348336"/>
            <a:ext cx="3193706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27862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A8833-365E-BD48-8227-B88281AB6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828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9607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4706" indent="-524706" algn="l" defTabSz="699607" rtl="0" eaLnBrk="1" latinLnBrk="0" hangingPunct="1">
        <a:spcBef>
          <a:spcPct val="20000"/>
        </a:spcBef>
        <a:buFont typeface="Arial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136862" indent="-437255" algn="l" defTabSz="699607" rtl="0" eaLnBrk="1" latinLnBrk="0" hangingPunct="1">
        <a:spcBef>
          <a:spcPct val="20000"/>
        </a:spcBef>
        <a:buFont typeface="Arial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49019" indent="-349804" algn="l" defTabSz="699607" rtl="0" eaLnBrk="1" latinLnBrk="0" hangingPunct="1">
        <a:spcBef>
          <a:spcPct val="20000"/>
        </a:spcBef>
        <a:buFont typeface="Arial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448626" indent="-349804" algn="l" defTabSz="699607" rtl="0" eaLnBrk="1" latinLnBrk="0" hangingPunct="1">
        <a:spcBef>
          <a:spcPct val="20000"/>
        </a:spcBef>
        <a:buFont typeface="Arial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8233" indent="-349804" algn="l" defTabSz="699607" rtl="0" eaLnBrk="1" latinLnBrk="0" hangingPunct="1">
        <a:spcBef>
          <a:spcPct val="20000"/>
        </a:spcBef>
        <a:buFont typeface="Arial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847841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547448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247056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5946663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9960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39921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09882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79843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49803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9764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9725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9686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lamar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6844" y="6385262"/>
            <a:ext cx="5322240" cy="4320000"/>
          </a:xfrm>
          <a:prstGeom prst="rect">
            <a:avLst/>
          </a:prstGeom>
        </p:spPr>
      </p:pic>
      <p:pic>
        <p:nvPicPr>
          <p:cNvPr id="5" name="Picture 4" descr="ROS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381" y="1582563"/>
            <a:ext cx="5510551" cy="432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49167"/>
            <a:ext cx="348146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3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135901" y="6609414"/>
            <a:ext cx="1748195" cy="461665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400" b="1" dirty="0" err="1" smtClean="0"/>
              <a:t>Alamar</a:t>
            </a:r>
            <a:r>
              <a:rPr lang="en-US" sz="2400" b="1" dirty="0" smtClean="0"/>
              <a:t> Blue</a:t>
            </a:r>
            <a:endParaRPr lang="en-US" sz="2400" b="1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913358" y="2912482"/>
            <a:ext cx="22629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/>
              <a:t>Luminescence Units </a:t>
            </a:r>
          </a:p>
          <a:p>
            <a:pPr algn="ctr"/>
            <a:r>
              <a:rPr lang="en-US" sz="2000" dirty="0" smtClean="0"/>
              <a:t>indicative of ROS </a:t>
            </a:r>
            <a:endParaRPr lang="en-US" sz="20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358544" y="8011543"/>
            <a:ext cx="16803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% Cell Survival</a:t>
            </a:r>
            <a:endParaRPr lang="en-US" sz="2000" dirty="0"/>
          </a:p>
        </p:txBody>
      </p:sp>
      <p:sp>
        <p:nvSpPr>
          <p:cNvPr id="10" name="TextBox 9"/>
          <p:cNvSpPr txBox="1"/>
          <p:nvPr/>
        </p:nvSpPr>
        <p:spPr>
          <a:xfrm>
            <a:off x="6442146" y="1606615"/>
            <a:ext cx="12429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ROS-</a:t>
            </a:r>
            <a:r>
              <a:rPr lang="en-US" sz="2400" b="1" dirty="0" err="1" smtClean="0"/>
              <a:t>Glo</a:t>
            </a:r>
            <a:endParaRPr lang="en-US" sz="2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465544" y="1276937"/>
            <a:ext cx="3898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465544" y="6458701"/>
            <a:ext cx="37156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6630107" y="2885776"/>
            <a:ext cx="787400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820607" y="2576054"/>
            <a:ext cx="35072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4833310" y="7976699"/>
            <a:ext cx="787400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023810" y="7666977"/>
            <a:ext cx="35072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1633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0</Words>
  <Application>Microsoft Macintosh PowerPoint</Application>
  <PresentationFormat>Custom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na Frame</dc:creator>
  <cp:lastModifiedBy>Fiona Frame</cp:lastModifiedBy>
  <cp:revision>3</cp:revision>
  <dcterms:created xsi:type="dcterms:W3CDTF">2015-04-24T11:31:03Z</dcterms:created>
  <dcterms:modified xsi:type="dcterms:W3CDTF">2015-04-24T12:21:29Z</dcterms:modified>
</cp:coreProperties>
</file>